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4" d="100"/>
          <a:sy n="84" d="100"/>
        </p:scale>
        <p:origin x="29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977790-11B8-44C7-B721-D87F7B572278}" type="datetimeFigureOut">
              <a:rPr lang="zh-CN" altLang="en-US" smtClean="0"/>
              <a:t>2022/3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09A01-6AA2-4177-93C3-4BEE974D6A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63318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977790-11B8-44C7-B721-D87F7B572278}" type="datetimeFigureOut">
              <a:rPr lang="zh-CN" altLang="en-US" smtClean="0"/>
              <a:t>2022/3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09A01-6AA2-4177-93C3-4BEE974D6A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13218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977790-11B8-44C7-B721-D87F7B572278}" type="datetimeFigureOut">
              <a:rPr lang="zh-CN" altLang="en-US" smtClean="0"/>
              <a:t>2022/3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09A01-6AA2-4177-93C3-4BEE974D6A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82955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977790-11B8-44C7-B721-D87F7B572278}" type="datetimeFigureOut">
              <a:rPr lang="zh-CN" altLang="en-US" smtClean="0"/>
              <a:t>2022/3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09A01-6AA2-4177-93C3-4BEE974D6A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91277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977790-11B8-44C7-B721-D87F7B572278}" type="datetimeFigureOut">
              <a:rPr lang="zh-CN" altLang="en-US" smtClean="0"/>
              <a:t>2022/3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09A01-6AA2-4177-93C3-4BEE974D6A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571896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977790-11B8-44C7-B721-D87F7B572278}" type="datetimeFigureOut">
              <a:rPr lang="zh-CN" altLang="en-US" smtClean="0"/>
              <a:t>2022/3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09A01-6AA2-4177-93C3-4BEE974D6A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72242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977790-11B8-44C7-B721-D87F7B572278}" type="datetimeFigureOut">
              <a:rPr lang="zh-CN" altLang="en-US" smtClean="0"/>
              <a:t>2022/3/1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09A01-6AA2-4177-93C3-4BEE974D6A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989327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977790-11B8-44C7-B721-D87F7B572278}" type="datetimeFigureOut">
              <a:rPr lang="zh-CN" altLang="en-US" smtClean="0"/>
              <a:t>2022/3/1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09A01-6AA2-4177-93C3-4BEE974D6A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25657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977790-11B8-44C7-B721-D87F7B572278}" type="datetimeFigureOut">
              <a:rPr lang="zh-CN" altLang="en-US" smtClean="0"/>
              <a:t>2022/3/1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09A01-6AA2-4177-93C3-4BEE974D6A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69561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977790-11B8-44C7-B721-D87F7B572278}" type="datetimeFigureOut">
              <a:rPr lang="zh-CN" altLang="en-US" smtClean="0"/>
              <a:t>2022/3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09A01-6AA2-4177-93C3-4BEE974D6A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379819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977790-11B8-44C7-B721-D87F7B572278}" type="datetimeFigureOut">
              <a:rPr lang="zh-CN" altLang="en-US" smtClean="0"/>
              <a:t>2022/3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09A01-6AA2-4177-93C3-4BEE974D6A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424710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977790-11B8-44C7-B721-D87F7B572278}" type="datetimeFigureOut">
              <a:rPr lang="zh-CN" altLang="en-US" smtClean="0"/>
              <a:t>2022/3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E09A01-6AA2-4177-93C3-4BEE974D6A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189535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4120" y="0"/>
            <a:ext cx="8547652" cy="685800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313512" y="354619"/>
            <a:ext cx="19454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KBP39 (0.8s)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" name="直接连接符 3"/>
          <p:cNvCxnSpPr/>
          <p:nvPr/>
        </p:nvCxnSpPr>
        <p:spPr>
          <a:xfrm flipH="1" flipV="1">
            <a:off x="4217341" y="3417107"/>
            <a:ext cx="27316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" name="文本框 4"/>
          <p:cNvSpPr txBox="1"/>
          <p:nvPr/>
        </p:nvSpPr>
        <p:spPr>
          <a:xfrm>
            <a:off x="3378107" y="3232441"/>
            <a:ext cx="9416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7 </a:t>
            </a:r>
            <a:r>
              <a:rPr lang="en-US" altLang="zh-CN" dirty="0" err="1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" name="直接连接符 5"/>
          <p:cNvCxnSpPr/>
          <p:nvPr/>
        </p:nvCxnSpPr>
        <p:spPr>
          <a:xfrm flipH="1" flipV="1">
            <a:off x="4217341" y="4081494"/>
            <a:ext cx="27316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文本框 6"/>
          <p:cNvSpPr txBox="1"/>
          <p:nvPr/>
        </p:nvSpPr>
        <p:spPr>
          <a:xfrm>
            <a:off x="3378107" y="3896828"/>
            <a:ext cx="9416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0 </a:t>
            </a:r>
            <a:r>
              <a:rPr lang="en-US" altLang="zh-CN" dirty="0" err="1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 rot="19062061">
            <a:off x="4976872" y="1809218"/>
            <a:ext cx="18753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altLang="zh-CN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rst instar (40h)</a:t>
            </a:r>
            <a:endParaRPr lang="zh-CN" altLang="en-US" sz="1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 rot="19062061">
            <a:off x="5458516" y="1809220"/>
            <a:ext cx="18753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econd instar (64h)</a:t>
            </a:r>
            <a:endParaRPr lang="zh-CN" altLang="en-US" sz="1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 rot="19062061">
            <a:off x="6007394" y="1760455"/>
            <a:ext cx="18753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ird instar (96h)</a:t>
            </a:r>
            <a:endParaRPr lang="zh-CN" altLang="en-US" sz="1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 rot="19062061">
            <a:off x="6534655" y="1760455"/>
            <a:ext cx="202022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ate third instar (110h)</a:t>
            </a:r>
            <a:endParaRPr lang="zh-CN" altLang="en-US" sz="1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 rot="19062061">
            <a:off x="7046182" y="1760454"/>
            <a:ext cx="202022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err="1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uparium</a:t>
            </a:r>
            <a:r>
              <a:rPr lang="en-US" altLang="zh-CN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120h)</a:t>
            </a:r>
            <a:endParaRPr lang="zh-CN" altLang="en-US" sz="1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 rot="19062061">
            <a:off x="7645103" y="1711688"/>
            <a:ext cx="202022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h AP (123h)</a:t>
            </a:r>
            <a:endParaRPr lang="zh-CN" altLang="en-US" sz="1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 rot="19062061">
            <a:off x="8167944" y="1760455"/>
            <a:ext cx="202022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h AP (126h)</a:t>
            </a:r>
            <a:endParaRPr lang="zh-CN" altLang="en-US" sz="1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 rot="19062061">
            <a:off x="8725677" y="1711688"/>
            <a:ext cx="202022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7 (170h)</a:t>
            </a:r>
            <a:endParaRPr lang="zh-CN" altLang="en-US" sz="1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 rot="19062061">
            <a:off x="9237204" y="1736073"/>
            <a:ext cx="202022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9 (190h)</a:t>
            </a:r>
            <a:endParaRPr lang="zh-CN" altLang="en-US" sz="1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 rot="19062061">
            <a:off x="9740615" y="1760454"/>
            <a:ext cx="202022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le </a:t>
            </a:r>
            <a:r>
              <a:rPr lang="en-US" altLang="zh-CN" sz="1600" dirty="0" err="1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dut</a:t>
            </a:r>
            <a:endParaRPr lang="zh-CN" altLang="en-US" sz="1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 rot="19062061">
            <a:off x="10320844" y="1686104"/>
            <a:ext cx="202022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kbp39 mutant </a:t>
            </a:r>
            <a:r>
              <a:rPr lang="zh-CN" altLang="en-US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（ </a:t>
            </a:r>
            <a:r>
              <a:rPr lang="en-US" altLang="zh-CN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egative control</a:t>
            </a:r>
            <a:r>
              <a:rPr lang="zh-CN" altLang="en-US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）</a:t>
            </a:r>
            <a:endParaRPr lang="zh-CN" altLang="en-US" sz="1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407086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95631" y="0"/>
            <a:ext cx="8547652" cy="6858000"/>
          </a:xfrm>
          <a:prstGeom prst="rect">
            <a:avLst/>
          </a:prstGeom>
        </p:spPr>
      </p:pic>
      <p:cxnSp>
        <p:nvCxnSpPr>
          <p:cNvPr id="4" name="直接连接符 3"/>
          <p:cNvCxnSpPr/>
          <p:nvPr/>
        </p:nvCxnSpPr>
        <p:spPr>
          <a:xfrm flipH="1" flipV="1">
            <a:off x="3132798" y="4242804"/>
            <a:ext cx="27316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" name="文本框 4"/>
          <p:cNvSpPr txBox="1"/>
          <p:nvPr/>
        </p:nvSpPr>
        <p:spPr>
          <a:xfrm>
            <a:off x="2274747" y="4026587"/>
            <a:ext cx="9416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2 </a:t>
            </a:r>
            <a:r>
              <a:rPr lang="en-US" altLang="zh-CN" dirty="0" err="1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" name="直接连接符 5"/>
          <p:cNvCxnSpPr/>
          <p:nvPr/>
        </p:nvCxnSpPr>
        <p:spPr>
          <a:xfrm flipH="1" flipV="1">
            <a:off x="3132798" y="3722527"/>
            <a:ext cx="27316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文本框 6"/>
          <p:cNvSpPr txBox="1"/>
          <p:nvPr/>
        </p:nvSpPr>
        <p:spPr>
          <a:xfrm>
            <a:off x="2274747" y="3537861"/>
            <a:ext cx="9416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6 </a:t>
            </a:r>
            <a:r>
              <a:rPr lang="en-US" altLang="zh-CN" dirty="0" err="1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" name="直接连接符 7"/>
          <p:cNvCxnSpPr/>
          <p:nvPr/>
        </p:nvCxnSpPr>
        <p:spPr>
          <a:xfrm flipH="1" flipV="1">
            <a:off x="3132798" y="3156340"/>
            <a:ext cx="27316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2274747" y="3000724"/>
            <a:ext cx="9416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95 </a:t>
            </a:r>
            <a:r>
              <a:rPr lang="en-US" altLang="zh-CN" dirty="0" err="1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" name="直接连接符 9"/>
          <p:cNvCxnSpPr/>
          <p:nvPr/>
        </p:nvCxnSpPr>
        <p:spPr>
          <a:xfrm flipH="1" flipV="1">
            <a:off x="3132798" y="2636064"/>
            <a:ext cx="27316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文本框 10"/>
          <p:cNvSpPr txBox="1"/>
          <p:nvPr/>
        </p:nvSpPr>
        <p:spPr>
          <a:xfrm>
            <a:off x="2144111" y="2432948"/>
            <a:ext cx="11030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30 </a:t>
            </a:r>
            <a:r>
              <a:rPr lang="en-US" altLang="zh-CN" dirty="0" err="1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 rot="19062061">
            <a:off x="3862665" y="1507422"/>
            <a:ext cx="18753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altLang="zh-CN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rst instar (40h)</a:t>
            </a:r>
            <a:endParaRPr lang="zh-CN" altLang="en-US" sz="1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 rot="19062061">
            <a:off x="4344309" y="1507424"/>
            <a:ext cx="18753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econd instar (64h)</a:t>
            </a:r>
            <a:endParaRPr lang="zh-CN" altLang="en-US" sz="1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 rot="19062061">
            <a:off x="4893187" y="1458659"/>
            <a:ext cx="18753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ird instar (96h)</a:t>
            </a:r>
            <a:endParaRPr lang="zh-CN" altLang="en-US" sz="1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 rot="19062061">
            <a:off x="5420448" y="1458659"/>
            <a:ext cx="202022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ate third instar (110h)</a:t>
            </a:r>
            <a:endParaRPr lang="zh-CN" altLang="en-US" sz="1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 rot="19062061">
            <a:off x="5931975" y="1458658"/>
            <a:ext cx="202022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err="1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uparium</a:t>
            </a:r>
            <a:r>
              <a:rPr lang="en-US" altLang="zh-CN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120h)</a:t>
            </a:r>
            <a:endParaRPr lang="zh-CN" altLang="en-US" sz="1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 rot="19062061">
            <a:off x="6530896" y="1409892"/>
            <a:ext cx="202022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h AP (123h)</a:t>
            </a:r>
            <a:endParaRPr lang="zh-CN" altLang="en-US" sz="1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 rot="19062061">
            <a:off x="7053737" y="1458659"/>
            <a:ext cx="202022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h AP (126h)</a:t>
            </a:r>
            <a:endParaRPr lang="zh-CN" altLang="en-US" sz="1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 rot="19062061">
            <a:off x="7611470" y="1409892"/>
            <a:ext cx="202022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7 (170h)</a:t>
            </a:r>
            <a:endParaRPr lang="zh-CN" altLang="en-US" sz="1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 rot="19062061">
            <a:off x="8122997" y="1434277"/>
            <a:ext cx="202022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9 (190h)</a:t>
            </a:r>
            <a:endParaRPr lang="zh-CN" altLang="en-US" sz="1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 rot="19062061">
            <a:off x="8626408" y="1458658"/>
            <a:ext cx="202022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le </a:t>
            </a:r>
            <a:r>
              <a:rPr lang="en-US" altLang="zh-CN" sz="1600" dirty="0" err="1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dut</a:t>
            </a:r>
            <a:endParaRPr lang="zh-CN" altLang="en-US" sz="1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573206" y="436728"/>
            <a:ext cx="19454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ubulin (3s)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 rot="19062061">
            <a:off x="9234531" y="1539681"/>
            <a:ext cx="202022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kbp39 mutant </a:t>
            </a:r>
            <a:r>
              <a:rPr lang="zh-CN" altLang="en-US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（ </a:t>
            </a:r>
            <a:r>
              <a:rPr lang="en-US" altLang="zh-CN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egative control</a:t>
            </a:r>
            <a:r>
              <a:rPr lang="zh-CN" altLang="en-US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）</a:t>
            </a:r>
            <a:endParaRPr lang="zh-CN" altLang="en-US" sz="1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042618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0</TotalTime>
  <Words>122</Words>
  <Application>Microsoft Office PowerPoint</Application>
  <PresentationFormat>宽屏</PresentationFormat>
  <Paragraphs>30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</vt:vector>
  </TitlesOfParts>
  <Company>微软中国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微软用户</dc:creator>
  <cp:lastModifiedBy>Windows User</cp:lastModifiedBy>
  <cp:revision>14</cp:revision>
  <dcterms:created xsi:type="dcterms:W3CDTF">2022-03-18T04:54:29Z</dcterms:created>
  <dcterms:modified xsi:type="dcterms:W3CDTF">2022-03-18T07:54:57Z</dcterms:modified>
</cp:coreProperties>
</file>